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handoutMasterIdLst>
    <p:handoutMasterId r:id="rId4"/>
  </p:handoutMasterIdLst>
  <p:sldIdLst>
    <p:sldId id="26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1E1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83"/>
    <p:restoredTop sz="86351"/>
  </p:normalViewPr>
  <p:slideViewPr>
    <p:cSldViewPr snapToGrid="0">
      <p:cViewPr varScale="1">
        <p:scale>
          <a:sx n="126" d="100"/>
          <a:sy n="126" d="100"/>
        </p:scale>
        <p:origin x="1308" y="13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>
      <p:cViewPr varScale="1">
        <p:scale>
          <a:sx n="96" d="100"/>
          <a:sy n="96" d="100"/>
        </p:scale>
        <p:origin x="3688" y="17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>
            <a:extLst>
              <a:ext uri="{FF2B5EF4-FFF2-40B4-BE49-F238E27FC236}">
                <a16:creationId xmlns:a16="http://schemas.microsoft.com/office/drawing/2014/main" id="{E9134F97-D4AF-B8E4-7755-A004E2077EA6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495F299D-E23C-8547-543F-526E7B3BCC5E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8577C9-8DD2-6542-B0E7-CEC63B6533AA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3C0999E-9E3E-0ACE-F3FE-011E9745E7F1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DC19F892-3E3F-FF76-BD1D-DAFFAFDEB079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48B0CE-51C5-3A4E-8A5E-753CC73748B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343083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2AB0CF-9910-0643-9DDA-8F471B16C7CF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D55BF5-FF28-1F4A-9B40-5F242A23BD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53733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181" indent="0" algn="ctr">
              <a:buNone/>
              <a:defRPr sz="2000"/>
            </a:lvl2pPr>
            <a:lvl3pPr marL="914362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3" indent="0" algn="ctr">
              <a:buNone/>
              <a:defRPr sz="1600"/>
            </a:lvl5pPr>
            <a:lvl6pPr marL="2285905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6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2566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6014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1870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228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1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1" y="4589466"/>
            <a:ext cx="8543925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/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5909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9121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3675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250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83126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087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199"/>
            </a:lvl1pPr>
            <a:lvl2pPr marL="457181" indent="0">
              <a:buNone/>
              <a:defRPr sz="2799"/>
            </a:lvl2pPr>
            <a:lvl3pPr marL="914362" indent="0">
              <a:buNone/>
              <a:defRPr sz="2401"/>
            </a:lvl3pPr>
            <a:lvl4pPr marL="1371543" indent="0">
              <a:buNone/>
              <a:defRPr sz="2000"/>
            </a:lvl4pPr>
            <a:lvl5pPr marL="1828723" indent="0">
              <a:buNone/>
              <a:defRPr sz="2000"/>
            </a:lvl5pPr>
            <a:lvl6pPr marL="2285905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6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5266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4B0921-4CE8-2540-981E-F17BA0C949EE}" type="datetimeFigureOut">
              <a:rPr lang="de-DE" smtClean="0"/>
              <a:t>19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8BB689-D6C3-294F-8CF3-A197881E5E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591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36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71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2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DBA15DC2-C480-D3F4-C95A-00B51F9FF2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63554" y="281162"/>
            <a:ext cx="4742784" cy="2596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74295" tIns="37148" rIns="74295" bIns="37148" numCol="1" anchor="ctr" anchorCtr="0" compatLnSpc="1">
            <a:prstTxWarp prst="textNoShape">
              <a:avLst/>
            </a:prstTxWarp>
            <a:spAutoFit/>
          </a:bodyPr>
          <a:lstStyle/>
          <a:p>
            <a:pPr defTabSz="7428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de-DE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altLang="de-DE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altLang="de-DE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altLang="de-DE" sz="1200" dirty="0">
              <a:latin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1963554" y="681275"/>
            <a:ext cx="5455920" cy="56483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teps of the data management process:</a:t>
            </a: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07000"/>
              </a:lnSpc>
              <a:spcAft>
                <a:spcPts val="800"/>
              </a:spcAft>
              <a:buFont typeface="+mj-lt"/>
              <a:buAutoNum type="arabicPeriod"/>
              <a:tabLst>
                <a:tab pos="457200" algn="l"/>
              </a:tabLst>
            </a:pPr>
            <a:r>
              <a:rPr lang="en-US" sz="12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edical letters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/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—&gt; Mostly outpatient visits / some inpatient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—&gt; Documentation: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. Diagnosis and diagnosis date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B. Previous therapies (in-hospital / </a:t>
            </a:r>
            <a:r>
              <a:rPr lang="en-US" sz="1200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namnestically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out-of-hospital) + recording if sufficient data is available (time period, reason for adjustment, side effects)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. Current therapy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. Therapy tolerability —&gt; written documentation of adverse events (AE) yes/no + type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. Planned/successful therapy switch —&gt; follow-up therapy/reason for switch</a:t>
            </a: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07000"/>
              </a:lnSpc>
              <a:spcAft>
                <a:spcPts val="800"/>
              </a:spcAft>
              <a:buFont typeface="+mj-lt"/>
              <a:buAutoNum type="arabicPeriod"/>
              <a:tabLst>
                <a:tab pos="457200" algn="l"/>
              </a:tabLst>
            </a:pPr>
            <a:r>
              <a:rPr lang="en-US" sz="12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Visits/journal documentation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(for supplementation/in case no medical letter is available)</a:t>
            </a: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07000"/>
              </a:lnSpc>
              <a:spcAft>
                <a:spcPts val="800"/>
              </a:spcAft>
              <a:buFont typeface="+mj-lt"/>
              <a:buAutoNum type="arabicPeriod"/>
              <a:tabLst>
                <a:tab pos="457200" algn="l"/>
              </a:tabLst>
            </a:pPr>
            <a:r>
              <a:rPr lang="en-US" sz="12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ata entry in Excel list based on predefined criteria</a:t>
            </a: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07000"/>
              </a:lnSpc>
              <a:spcAft>
                <a:spcPts val="800"/>
              </a:spcAft>
              <a:buFont typeface="+mj-lt"/>
              <a:buAutoNum type="arabicPeriod"/>
              <a:tabLst>
                <a:tab pos="457200" algn="l"/>
              </a:tabLst>
            </a:pPr>
            <a:r>
              <a:rPr lang="en-US" sz="12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nterpretation of recorded AEs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/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s it included in the product information?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—&gt; YES</a:t>
            </a: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lvl="1" indent="-285750">
              <a:lnSpc>
                <a:spcPct val="107000"/>
              </a:lnSpc>
              <a:spcAft>
                <a:spcPts val="800"/>
              </a:spcAft>
              <a:buSzPts val="1000"/>
              <a:buFont typeface="Courier New" panose="02070309020205020404" pitchFamily="49" charset="0"/>
              <a:buChar char="o"/>
              <a:tabLst>
                <a:tab pos="914400" algn="l"/>
              </a:tabLst>
            </a:pP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rapy continued?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—&gt; YES — usual, ordinary severity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—&gt; NO — usual, but not tolerated by the patient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—&gt; NO — usual, but significantly severe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—&gt; NO</a:t>
            </a: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lvl="1" indent="-285750">
              <a:lnSpc>
                <a:spcPct val="107000"/>
              </a:lnSpc>
              <a:spcAft>
                <a:spcPts val="800"/>
              </a:spcAft>
              <a:buSzPts val="1000"/>
              <a:buFont typeface="Courier New" panose="02070309020205020404" pitchFamily="49" charset="0"/>
              <a:buChar char="o"/>
              <a:tabLst>
                <a:tab pos="914400" algn="l"/>
              </a:tabLst>
            </a:pP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ross-check with PubMed and </a:t>
            </a:r>
            <a:r>
              <a:rPr lang="en-US" sz="1200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udraVigilance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: are case reports available/in studies previously described? —&gt; YES</a:t>
            </a:r>
            <a:b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</a:b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                                       </a:t>
            </a:r>
            <a:r>
              <a:rPr lang="en-US" sz="1200" dirty="0" smtClean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                                  —&gt; 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NO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41245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185</Words>
  <Application>Microsoft Office PowerPoint</Application>
  <PresentationFormat>A4-Papier (210 x 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irschbaum, Amelie</dc:creator>
  <cp:lastModifiedBy>Lüssi, Felix</cp:lastModifiedBy>
  <cp:revision>36</cp:revision>
  <dcterms:created xsi:type="dcterms:W3CDTF">2023-11-20T19:14:02Z</dcterms:created>
  <dcterms:modified xsi:type="dcterms:W3CDTF">2024-12-19T16:45:26Z</dcterms:modified>
</cp:coreProperties>
</file>